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  <p15:guide id="3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689" autoAdjust="0"/>
    <p:restoredTop sz="95982" autoAdjust="0"/>
  </p:normalViewPr>
  <p:slideViewPr>
    <p:cSldViewPr showGuides="1">
      <p:cViewPr varScale="1">
        <p:scale>
          <a:sx n="97" d="100"/>
          <a:sy n="97" d="100"/>
        </p:scale>
        <p:origin x="2904" y="96"/>
      </p:cViewPr>
      <p:guideLst>
        <p:guide orient="horz" pos="2880"/>
        <p:guide pos="2160"/>
        <p:guide/>
      </p:guideLst>
    </p:cSldViewPr>
  </p:slideViewPr>
  <p:notesTextViewPr>
    <p:cViewPr>
      <p:scale>
        <a:sx n="66" d="100"/>
        <a:sy n="66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H:\&#30740;&#31350;\&#23455;&#39443;&#12487;&#12540;&#12479;\&#23546;&#26449;&#12487;&#12540;&#12479;\NMR\NMR%20&#26377;&#27231;&#28342;&#23186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1"/>
          <c:order val="1"/>
          <c:tx>
            <c:strRef>
              <c:f>様々な有機溶媒!$C$1</c:f>
              <c:strCache>
                <c:ptCount val="1"/>
                <c:pt idx="0">
                  <c:v>No302_sorghum_H2SO4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様々な有機溶媒!$J$2:$J$48</c:f>
              <c:strCache>
                <c:ptCount val="29"/>
                <c:pt idx="0">
                  <c:v>p-Coumarate (1)</c:v>
                </c:pt>
                <c:pt idx="1">
                  <c:v>p-Coumarate (2)</c:v>
                </c:pt>
                <c:pt idx="2">
                  <c:v>p-Coumarate (3)</c:v>
                </c:pt>
                <c:pt idx="3">
                  <c:v>p-Coumarate (4)</c:v>
                </c:pt>
                <c:pt idx="4">
                  <c:v>p-Coumarate (5)</c:v>
                </c:pt>
                <c:pt idx="5">
                  <c:v>p-Coumarate (6)</c:v>
                </c:pt>
                <c:pt idx="6">
                  <c:v>Guaiacyl (7)</c:v>
                </c:pt>
                <c:pt idx="7">
                  <c:v>Guaiacyl (8)</c:v>
                </c:pt>
                <c:pt idx="8">
                  <c:v>Guaiacyl (9)</c:v>
                </c:pt>
                <c:pt idx="9">
                  <c:v>Guaiacyl (10)</c:v>
                </c:pt>
                <c:pt idx="10">
                  <c:v>Syringyl (11)</c:v>
                </c:pt>
                <c:pt idx="11">
                  <c:v>Syringyl (12)</c:v>
                </c:pt>
                <c:pt idx="12">
                  <c:v>p-Hydroxyphenyl (13)</c:v>
                </c:pt>
                <c:pt idx="13">
                  <c:v>Cinnamyl alcohol (14)</c:v>
                </c:pt>
                <c:pt idx="14">
                  <c:v>Ferulate (15)</c:v>
                </c:pt>
                <c:pt idx="15">
                  <c:v>Ferulate (16)</c:v>
                </c:pt>
                <c:pt idx="16">
                  <c:v>Methoxyl (17)</c:v>
                </c:pt>
                <c:pt idx="17">
                  <c:v>Methoxyl (18)</c:v>
                </c:pt>
                <c:pt idx="18">
                  <c:v>5-5/4-O-β (19)</c:v>
                </c:pt>
                <c:pt idx="19">
                  <c:v>5-5/4-O-β (20)</c:v>
                </c:pt>
                <c:pt idx="20">
                  <c:v>β-O-4 (21)</c:v>
                </c:pt>
                <c:pt idx="21">
                  <c:v>β-O-4 (22)</c:v>
                </c:pt>
                <c:pt idx="22">
                  <c:v>β-O-4 (23)</c:v>
                </c:pt>
                <c:pt idx="23">
                  <c:v>β-O-4-H/G (24)</c:v>
                </c:pt>
                <c:pt idx="24">
                  <c:v>β-O-4-H/G (25)</c:v>
                </c:pt>
                <c:pt idx="25">
                  <c:v>β-O-4-H/G (26)</c:v>
                </c:pt>
                <c:pt idx="26">
                  <c:v>β-O-4-H/G (27)</c:v>
                </c:pt>
                <c:pt idx="27">
                  <c:v>β-O-4-S (28)</c:v>
                </c:pt>
                <c:pt idx="28">
                  <c:v>β-5 (29)</c:v>
                </c:pt>
              </c:strCache>
            </c:strRef>
          </c:cat>
          <c:val>
            <c:numRef>
              <c:f>様々な有機溶媒!$C$2:$C$48</c:f>
              <c:numCache>
                <c:formatCode>General</c:formatCode>
                <c:ptCount val="29"/>
                <c:pt idx="0">
                  <c:v>0.97268672635579212</c:v>
                </c:pt>
                <c:pt idx="1">
                  <c:v>2.7969360590862991</c:v>
                </c:pt>
                <c:pt idx="2">
                  <c:v>3.2612697409650226</c:v>
                </c:pt>
                <c:pt idx="3">
                  <c:v>2.1777085729946566</c:v>
                </c:pt>
                <c:pt idx="4">
                  <c:v>9.5364343981133164</c:v>
                </c:pt>
                <c:pt idx="5">
                  <c:v>0.5081086553886921</c:v>
                </c:pt>
                <c:pt idx="6">
                  <c:v>0.73653965998495263</c:v>
                </c:pt>
                <c:pt idx="7">
                  <c:v>0.67158330962177293</c:v>
                </c:pt>
                <c:pt idx="8">
                  <c:v>2.1571247274625254</c:v>
                </c:pt>
                <c:pt idx="9">
                  <c:v>2.0242563152758892</c:v>
                </c:pt>
                <c:pt idx="10">
                  <c:v>0.93508571947274799</c:v>
                </c:pt>
                <c:pt idx="11">
                  <c:v>1.0688135084322963</c:v>
                </c:pt>
                <c:pt idx="12">
                  <c:v>0.33411497110099031</c:v>
                </c:pt>
                <c:pt idx="13">
                  <c:v>0.23484901118429208</c:v>
                </c:pt>
                <c:pt idx="14">
                  <c:v>0.17142183825981003</c:v>
                </c:pt>
                <c:pt idx="15">
                  <c:v>0.29350117044916968</c:v>
                </c:pt>
                <c:pt idx="16">
                  <c:v>14.374576552263479</c:v>
                </c:pt>
                <c:pt idx="17">
                  <c:v>25.614755514901624</c:v>
                </c:pt>
                <c:pt idx="18">
                  <c:v>0.14567335303574888</c:v>
                </c:pt>
                <c:pt idx="19">
                  <c:v>7.8344508315338734E-2</c:v>
                </c:pt>
                <c:pt idx="20">
                  <c:v>0.6499585411367933</c:v>
                </c:pt>
                <c:pt idx="21">
                  <c:v>0.62451344750958793</c:v>
                </c:pt>
                <c:pt idx="22">
                  <c:v>0.49690882715930851</c:v>
                </c:pt>
                <c:pt idx="23">
                  <c:v>44.716737335844719</c:v>
                </c:pt>
                <c:pt idx="24">
                  <c:v>0.59325416290627508</c:v>
                </c:pt>
                <c:pt idx="25">
                  <c:v>0.48920550853005201</c:v>
                </c:pt>
                <c:pt idx="26">
                  <c:v>0.5287429498112094</c:v>
                </c:pt>
                <c:pt idx="27">
                  <c:v>8.1493461719067767E-2</c:v>
                </c:pt>
                <c:pt idx="28">
                  <c:v>0.17265198819251576</c:v>
                </c:pt>
              </c:numCache>
            </c:numRef>
          </c:val>
        </c:ser>
        <c:ser>
          <c:idx val="5"/>
          <c:order val="5"/>
          <c:tx>
            <c:strRef>
              <c:f>様々な有機溶媒!$G$1</c:f>
              <c:strCache>
                <c:ptCount val="1"/>
                <c:pt idx="0">
                  <c:v>No305_sorghum_H2SO4_BuOH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様々な有機溶媒!$J$2:$J$48</c:f>
              <c:strCache>
                <c:ptCount val="29"/>
                <c:pt idx="0">
                  <c:v>p-Coumarate (1)</c:v>
                </c:pt>
                <c:pt idx="1">
                  <c:v>p-Coumarate (2)</c:v>
                </c:pt>
                <c:pt idx="2">
                  <c:v>p-Coumarate (3)</c:v>
                </c:pt>
                <c:pt idx="3">
                  <c:v>p-Coumarate (4)</c:v>
                </c:pt>
                <c:pt idx="4">
                  <c:v>p-Coumarate (5)</c:v>
                </c:pt>
                <c:pt idx="5">
                  <c:v>p-Coumarate (6)</c:v>
                </c:pt>
                <c:pt idx="6">
                  <c:v>Guaiacyl (7)</c:v>
                </c:pt>
                <c:pt idx="7">
                  <c:v>Guaiacyl (8)</c:v>
                </c:pt>
                <c:pt idx="8">
                  <c:v>Guaiacyl (9)</c:v>
                </c:pt>
                <c:pt idx="9">
                  <c:v>Guaiacyl (10)</c:v>
                </c:pt>
                <c:pt idx="10">
                  <c:v>Syringyl (11)</c:v>
                </c:pt>
                <c:pt idx="11">
                  <c:v>Syringyl (12)</c:v>
                </c:pt>
                <c:pt idx="12">
                  <c:v>p-Hydroxyphenyl (13)</c:v>
                </c:pt>
                <c:pt idx="13">
                  <c:v>Cinnamyl alcohol (14)</c:v>
                </c:pt>
                <c:pt idx="14">
                  <c:v>Ferulate (15)</c:v>
                </c:pt>
                <c:pt idx="15">
                  <c:v>Ferulate (16)</c:v>
                </c:pt>
                <c:pt idx="16">
                  <c:v>Methoxyl (17)</c:v>
                </c:pt>
                <c:pt idx="17">
                  <c:v>Methoxyl (18)</c:v>
                </c:pt>
                <c:pt idx="18">
                  <c:v>5-5/4-O-β (19)</c:v>
                </c:pt>
                <c:pt idx="19">
                  <c:v>5-5/4-O-β (20)</c:v>
                </c:pt>
                <c:pt idx="20">
                  <c:v>β-O-4 (21)</c:v>
                </c:pt>
                <c:pt idx="21">
                  <c:v>β-O-4 (22)</c:v>
                </c:pt>
                <c:pt idx="22">
                  <c:v>β-O-4 (23)</c:v>
                </c:pt>
                <c:pt idx="23">
                  <c:v>β-O-4-H/G (24)</c:v>
                </c:pt>
                <c:pt idx="24">
                  <c:v>β-O-4-H/G (25)</c:v>
                </c:pt>
                <c:pt idx="25">
                  <c:v>β-O-4-H/G (26)</c:v>
                </c:pt>
                <c:pt idx="26">
                  <c:v>β-O-4-H/G (27)</c:v>
                </c:pt>
                <c:pt idx="27">
                  <c:v>β-O-4-S (28)</c:v>
                </c:pt>
                <c:pt idx="28">
                  <c:v>β-5 (29)</c:v>
                </c:pt>
              </c:strCache>
            </c:strRef>
          </c:cat>
          <c:val>
            <c:numRef>
              <c:f>様々な有機溶媒!$G$2:$G$48</c:f>
              <c:numCache>
                <c:formatCode>General</c:formatCode>
                <c:ptCount val="29"/>
                <c:pt idx="0">
                  <c:v>0.57506546433296335</c:v>
                </c:pt>
                <c:pt idx="1">
                  <c:v>1.3053867793981235</c:v>
                </c:pt>
                <c:pt idx="2">
                  <c:v>1.4060887151959367</c:v>
                </c:pt>
                <c:pt idx="3">
                  <c:v>0.75878225696081258</c:v>
                </c:pt>
                <c:pt idx="4">
                  <c:v>4.2263837228752603</c:v>
                </c:pt>
                <c:pt idx="5">
                  <c:v>0.29668526938458967</c:v>
                </c:pt>
                <c:pt idx="6">
                  <c:v>0.58384452791168018</c:v>
                </c:pt>
                <c:pt idx="7">
                  <c:v>0.86926628244704307</c:v>
                </c:pt>
                <c:pt idx="8">
                  <c:v>2.4006928118489683</c:v>
                </c:pt>
                <c:pt idx="9">
                  <c:v>1.2501391402198871</c:v>
                </c:pt>
                <c:pt idx="10">
                  <c:v>0.53935219963200076</c:v>
                </c:pt>
                <c:pt idx="11">
                  <c:v>0.66245495050257752</c:v>
                </c:pt>
                <c:pt idx="12">
                  <c:v>0.36391691123918429</c:v>
                </c:pt>
                <c:pt idx="13">
                  <c:v>0.25820440686729218</c:v>
                </c:pt>
                <c:pt idx="14">
                  <c:v>0.16950928361794984</c:v>
                </c:pt>
                <c:pt idx="15">
                  <c:v>0.19020209546691808</c:v>
                </c:pt>
                <c:pt idx="16">
                  <c:v>8.1694329465792794</c:v>
                </c:pt>
                <c:pt idx="17">
                  <c:v>13.379892641535257</c:v>
                </c:pt>
                <c:pt idx="18">
                  <c:v>0.16607989537871992</c:v>
                </c:pt>
                <c:pt idx="19">
                  <c:v>9.9281945225893772E-2</c:v>
                </c:pt>
                <c:pt idx="20">
                  <c:v>0.36179893858061768</c:v>
                </c:pt>
                <c:pt idx="21">
                  <c:v>0.36179893858061768</c:v>
                </c:pt>
                <c:pt idx="22">
                  <c:v>0.32403248125788842</c:v>
                </c:pt>
                <c:pt idx="23">
                  <c:v>56.387731330119678</c:v>
                </c:pt>
                <c:pt idx="24">
                  <c:v>0.69236264655342827</c:v>
                </c:pt>
                <c:pt idx="25">
                  <c:v>0.34526421435197152</c:v>
                </c:pt>
                <c:pt idx="26">
                  <c:v>0.34991651586806771</c:v>
                </c:pt>
                <c:pt idx="27">
                  <c:v>0.16379951643071122</c:v>
                </c:pt>
                <c:pt idx="28">
                  <c:v>0.47496358023752683</c:v>
                </c:pt>
              </c:numCache>
            </c:numRef>
          </c:val>
        </c:ser>
        <c:ser>
          <c:idx val="6"/>
          <c:order val="6"/>
          <c:tx>
            <c:strRef>
              <c:f>様々な有機溶媒!$H$1</c:f>
              <c:strCache>
                <c:ptCount val="1"/>
                <c:pt idx="0">
                  <c:v>No314_1_sorghum_H2SO4_PeOH_sol</c:v>
                </c:pt>
              </c:strCache>
            </c:strRef>
          </c:tx>
          <c:spPr>
            <a:solidFill>
              <a:schemeClr val="accent1">
                <a:lumMod val="60000"/>
              </a:schemeClr>
            </a:solidFill>
            <a:ln>
              <a:noFill/>
            </a:ln>
            <a:effectLst/>
          </c:spPr>
          <c:invertIfNegative val="0"/>
          <c:cat>
            <c:strRef>
              <c:f>様々な有機溶媒!$J$2:$J$48</c:f>
              <c:strCache>
                <c:ptCount val="29"/>
                <c:pt idx="0">
                  <c:v>p-Coumarate (1)</c:v>
                </c:pt>
                <c:pt idx="1">
                  <c:v>p-Coumarate (2)</c:v>
                </c:pt>
                <c:pt idx="2">
                  <c:v>p-Coumarate (3)</c:v>
                </c:pt>
                <c:pt idx="3">
                  <c:v>p-Coumarate (4)</c:v>
                </c:pt>
                <c:pt idx="4">
                  <c:v>p-Coumarate (5)</c:v>
                </c:pt>
                <c:pt idx="5">
                  <c:v>p-Coumarate (6)</c:v>
                </c:pt>
                <c:pt idx="6">
                  <c:v>Guaiacyl (7)</c:v>
                </c:pt>
                <c:pt idx="7">
                  <c:v>Guaiacyl (8)</c:v>
                </c:pt>
                <c:pt idx="8">
                  <c:v>Guaiacyl (9)</c:v>
                </c:pt>
                <c:pt idx="9">
                  <c:v>Guaiacyl (10)</c:v>
                </c:pt>
                <c:pt idx="10">
                  <c:v>Syringyl (11)</c:v>
                </c:pt>
                <c:pt idx="11">
                  <c:v>Syringyl (12)</c:v>
                </c:pt>
                <c:pt idx="12">
                  <c:v>p-Hydroxyphenyl (13)</c:v>
                </c:pt>
                <c:pt idx="13">
                  <c:v>Cinnamyl alcohol (14)</c:v>
                </c:pt>
                <c:pt idx="14">
                  <c:v>Ferulate (15)</c:v>
                </c:pt>
                <c:pt idx="15">
                  <c:v>Ferulate (16)</c:v>
                </c:pt>
                <c:pt idx="16">
                  <c:v>Methoxyl (17)</c:v>
                </c:pt>
                <c:pt idx="17">
                  <c:v>Methoxyl (18)</c:v>
                </c:pt>
                <c:pt idx="18">
                  <c:v>5-5/4-O-β (19)</c:v>
                </c:pt>
                <c:pt idx="19">
                  <c:v>5-5/4-O-β (20)</c:v>
                </c:pt>
                <c:pt idx="20">
                  <c:v>β-O-4 (21)</c:v>
                </c:pt>
                <c:pt idx="21">
                  <c:v>β-O-4 (22)</c:v>
                </c:pt>
                <c:pt idx="22">
                  <c:v>β-O-4 (23)</c:v>
                </c:pt>
                <c:pt idx="23">
                  <c:v>β-O-4-H/G (24)</c:v>
                </c:pt>
                <c:pt idx="24">
                  <c:v>β-O-4-H/G (25)</c:v>
                </c:pt>
                <c:pt idx="25">
                  <c:v>β-O-4-H/G (26)</c:v>
                </c:pt>
                <c:pt idx="26">
                  <c:v>β-O-4-H/G (27)</c:v>
                </c:pt>
                <c:pt idx="27">
                  <c:v>β-O-4-S (28)</c:v>
                </c:pt>
                <c:pt idx="28">
                  <c:v>β-5 (29)</c:v>
                </c:pt>
              </c:strCache>
            </c:strRef>
          </c:cat>
          <c:val>
            <c:numRef>
              <c:f>様々な有機溶媒!$H$2:$H$48</c:f>
              <c:numCache>
                <c:formatCode>General</c:formatCode>
                <c:ptCount val="29"/>
                <c:pt idx="0">
                  <c:v>1.049791603563103</c:v>
                </c:pt>
                <c:pt idx="1">
                  <c:v>1.6044333268593336</c:v>
                </c:pt>
                <c:pt idx="2">
                  <c:v>1.6278938644236858</c:v>
                </c:pt>
                <c:pt idx="3">
                  <c:v>0.74727997860890061</c:v>
                </c:pt>
                <c:pt idx="4">
                  <c:v>6.1922611134454577</c:v>
                </c:pt>
                <c:pt idx="5">
                  <c:v>0.33052611021473416</c:v>
                </c:pt>
                <c:pt idx="6">
                  <c:v>0.7346427670269331</c:v>
                </c:pt>
                <c:pt idx="7">
                  <c:v>0.64989371701017418</c:v>
                </c:pt>
                <c:pt idx="8">
                  <c:v>2.9322204509885044</c:v>
                </c:pt>
                <c:pt idx="9">
                  <c:v>1.3353434116113427</c:v>
                </c:pt>
                <c:pt idx="10">
                  <c:v>0.66592170836119757</c:v>
                </c:pt>
                <c:pt idx="11">
                  <c:v>0.96900953722379468</c:v>
                </c:pt>
                <c:pt idx="12">
                  <c:v>0.35862156530553063</c:v>
                </c:pt>
                <c:pt idx="13">
                  <c:v>0.19515665913638278</c:v>
                </c:pt>
                <c:pt idx="14">
                  <c:v>0.14275599782000165</c:v>
                </c:pt>
                <c:pt idx="15">
                  <c:v>0.31912819434050477</c:v>
                </c:pt>
                <c:pt idx="16">
                  <c:v>7.687108903614698</c:v>
                </c:pt>
                <c:pt idx="17">
                  <c:v>15.927364951200209</c:v>
                </c:pt>
                <c:pt idx="18">
                  <c:v>0.13036142672606965</c:v>
                </c:pt>
                <c:pt idx="19">
                  <c:v>5.6321914524911539E-2</c:v>
                </c:pt>
                <c:pt idx="20">
                  <c:v>0.32201835997626321</c:v>
                </c:pt>
                <c:pt idx="21">
                  <c:v>0.3572625633703248</c:v>
                </c:pt>
                <c:pt idx="22">
                  <c:v>0.3066480803694161</c:v>
                </c:pt>
                <c:pt idx="23">
                  <c:v>47.327673873967903</c:v>
                </c:pt>
                <c:pt idx="24">
                  <c:v>1.1780679899091686</c:v>
                </c:pt>
                <c:pt idx="25">
                  <c:v>0.46090851915595543</c:v>
                </c:pt>
                <c:pt idx="26">
                  <c:v>0.46090851915595543</c:v>
                </c:pt>
                <c:pt idx="27">
                  <c:v>0.14962283123251147</c:v>
                </c:pt>
                <c:pt idx="28">
                  <c:v>0.2165219342159134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300591504"/>
        <c:axId val="-300590960"/>
        <c:extLst>
          <c:ext xmlns:c15="http://schemas.microsoft.com/office/drawing/2012/chart" uri="{02D57815-91ED-43cb-92C2-25804820EDAC}">
            <c15:filteredBarSeries>
              <c15:ser>
                <c:idx val="0"/>
                <c:order val="0"/>
                <c:tx>
                  <c:strRef>
                    <c:extLst>
                      <c:ext uri="{02D57815-91ED-43cb-92C2-25804820EDAC}">
                        <c15:formulaRef>
                          <c15:sqref>様々な有機溶媒!$B$1</c15:sqref>
                        </c15:formulaRef>
                      </c:ext>
                    </c:extLst>
                    <c:strCache>
                      <c:ptCount val="1"/>
                      <c:pt idx="0">
                        <c:v>No301_sorghum</c:v>
                      </c:pt>
                    </c:strCache>
                  </c:strRef>
                </c:tx>
                <c:spPr>
                  <a:solidFill>
                    <a:schemeClr val="accent1"/>
                  </a:solidFill>
                  <a:ln>
                    <a:noFill/>
                  </a:ln>
                  <a:effectLst/>
                </c:spPr>
                <c:invertIfNegative val="0"/>
                <c:val>
                  <c:numRef>
                    <c:extLst>
                      <c:ext uri="{02D57815-91ED-43cb-92C2-25804820EDAC}">
                        <c15:formulaRef>
                          <c15:sqref>様々な有機溶媒!$B$2:$B$48</c15:sqref>
                        </c15:formulaRef>
                      </c:ext>
                    </c:extLst>
                    <c:numCache>
                      <c:formatCode>General</c:formatCode>
                      <c:ptCount val="29"/>
                      <c:pt idx="0">
                        <c:v>2.248505143830263</c:v>
                      </c:pt>
                      <c:pt idx="1">
                        <c:v>3.8848118800556639</c:v>
                      </c:pt>
                      <c:pt idx="2">
                        <c:v>3.7650784283199785</c:v>
                      </c:pt>
                      <c:pt idx="3">
                        <c:v>2.2730892529214031</c:v>
                      </c:pt>
                      <c:pt idx="4">
                        <c:v>14.281018662667675</c:v>
                      </c:pt>
                      <c:pt idx="5">
                        <c:v>1.4695297954541122</c:v>
                      </c:pt>
                      <c:pt idx="6">
                        <c:v>1.4255530650111519</c:v>
                      </c:pt>
                      <c:pt idx="7">
                        <c:v>0.83253877729979098</c:v>
                      </c:pt>
                      <c:pt idx="8">
                        <c:v>3.8269997871299397</c:v>
                      </c:pt>
                      <c:pt idx="9">
                        <c:v>1.8937158851899627</c:v>
                      </c:pt>
                      <c:pt idx="10">
                        <c:v>1.2371300985556608</c:v>
                      </c:pt>
                      <c:pt idx="11">
                        <c:v>1.5553585271933559</c:v>
                      </c:pt>
                      <c:pt idx="12">
                        <c:v>0.84604689177940307</c:v>
                      </c:pt>
                      <c:pt idx="13">
                        <c:v>1.0674980778151271</c:v>
                      </c:pt>
                      <c:pt idx="14">
                        <c:v>1.3234365964936807</c:v>
                      </c:pt>
                      <c:pt idx="15">
                        <c:v>2.4516316331263939</c:v>
                      </c:pt>
                      <c:pt idx="16">
                        <c:v>21.720716069465539</c:v>
                      </c:pt>
                      <c:pt idx="17">
                        <c:v>37.967910632700651</c:v>
                      </c:pt>
                      <c:pt idx="18">
                        <c:v>1.7882514789703443</c:v>
                      </c:pt>
                      <c:pt idx="19">
                        <c:v>0.65366041188768087</c:v>
                      </c:pt>
                      <c:pt idx="20">
                        <c:v>1.700207468879668</c:v>
                      </c:pt>
                      <c:pt idx="21">
                        <c:v>1.3739420040286454</c:v>
                      </c:pt>
                      <c:pt idx="22">
                        <c:v>1.4834521328309176</c:v>
                      </c:pt>
                      <c:pt idx="23">
                        <c:v>85.156818513976347</c:v>
                      </c:pt>
                      <c:pt idx="24">
                        <c:v>1.7032273642873936</c:v>
                      </c:pt>
                      <c:pt idx="25">
                        <c:v>1.3163276896290979</c:v>
                      </c:pt>
                      <c:pt idx="26">
                        <c:v>1.4589617501096122</c:v>
                      </c:pt>
                      <c:pt idx="27">
                        <c:v>3.3266463275148852</c:v>
                      </c:pt>
                      <c:pt idx="28">
                        <c:v>0.62681177838638136</c:v>
                      </c:pt>
                    </c:numCache>
                  </c:numRef>
                </c:val>
              </c15:ser>
            </c15:filteredBarSeries>
            <c15:filteredBarSeries>
              <c15:ser>
                <c:idx val="2"/>
                <c:order val="2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様々な有機溶媒!$D$1</c15:sqref>
                        </c15:formulaRef>
                      </c:ext>
                    </c:extLst>
                    <c:strCache>
                      <c:ptCount val="1"/>
                      <c:pt idx="0">
                        <c:v>No303_sorghum_H2SO4_EtOH</c:v>
                      </c:pt>
                    </c:strCache>
                  </c:strRef>
                </c:tx>
                <c:spPr>
                  <a:solidFill>
                    <a:schemeClr val="accent3"/>
                  </a:solidFill>
                  <a:ln>
                    <a:noFill/>
                  </a:ln>
                  <a:effectLst/>
                </c:spPr>
                <c:invertIfNegative val="0"/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様々な有機溶媒!$J$2:$J$48</c15:sqref>
                        </c15:formulaRef>
                      </c:ext>
                    </c:extLst>
                    <c:strCache>
                      <c:ptCount val="29"/>
                      <c:pt idx="0">
                        <c:v>p-Coumarate (1)</c:v>
                      </c:pt>
                      <c:pt idx="1">
                        <c:v>p-Coumarate (2)</c:v>
                      </c:pt>
                      <c:pt idx="2">
                        <c:v>p-Coumarate (3)</c:v>
                      </c:pt>
                      <c:pt idx="3">
                        <c:v>p-Coumarate (4)</c:v>
                      </c:pt>
                      <c:pt idx="4">
                        <c:v>p-Coumarate (5)</c:v>
                      </c:pt>
                      <c:pt idx="5">
                        <c:v>p-Coumarate (6)</c:v>
                      </c:pt>
                      <c:pt idx="6">
                        <c:v>Guaiacyl (7)</c:v>
                      </c:pt>
                      <c:pt idx="7">
                        <c:v>Guaiacyl (8)</c:v>
                      </c:pt>
                      <c:pt idx="8">
                        <c:v>Guaiacyl (9)</c:v>
                      </c:pt>
                      <c:pt idx="9">
                        <c:v>Guaiacyl (10)</c:v>
                      </c:pt>
                      <c:pt idx="10">
                        <c:v>Syringyl (11)</c:v>
                      </c:pt>
                      <c:pt idx="11">
                        <c:v>Syringyl (12)</c:v>
                      </c:pt>
                      <c:pt idx="12">
                        <c:v>p-Hydroxyphenyl (13)</c:v>
                      </c:pt>
                      <c:pt idx="13">
                        <c:v>Cinnamyl alcohol (14)</c:v>
                      </c:pt>
                      <c:pt idx="14">
                        <c:v>Ferulate (15)</c:v>
                      </c:pt>
                      <c:pt idx="15">
                        <c:v>Ferulate (16)</c:v>
                      </c:pt>
                      <c:pt idx="16">
                        <c:v>Methoxyl (17)</c:v>
                      </c:pt>
                      <c:pt idx="17">
                        <c:v>Methoxyl (18)</c:v>
                      </c:pt>
                      <c:pt idx="18">
                        <c:v>5-5/4-O-β (19)</c:v>
                      </c:pt>
                      <c:pt idx="19">
                        <c:v>5-5/4-O-β (20)</c:v>
                      </c:pt>
                      <c:pt idx="20">
                        <c:v>β-O-4 (21)</c:v>
                      </c:pt>
                      <c:pt idx="21">
                        <c:v>β-O-4 (22)</c:v>
                      </c:pt>
                      <c:pt idx="22">
                        <c:v>β-O-4 (23)</c:v>
                      </c:pt>
                      <c:pt idx="23">
                        <c:v>β-O-4-H/G (24)</c:v>
                      </c:pt>
                      <c:pt idx="24">
                        <c:v>β-O-4-H/G (25)</c:v>
                      </c:pt>
                      <c:pt idx="25">
                        <c:v>β-O-4-H/G (26)</c:v>
                      </c:pt>
                      <c:pt idx="26">
                        <c:v>β-O-4-H/G (27)</c:v>
                      </c:pt>
                      <c:pt idx="27">
                        <c:v>β-O-4-S (28)</c:v>
                      </c:pt>
                      <c:pt idx="28">
                        <c:v>β-5 (29)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様々な有機溶媒!$D$2:$D$48</c15:sqref>
                        </c15:formulaRef>
                      </c:ext>
                    </c:extLst>
                    <c:numCache>
                      <c:formatCode>General</c:formatCode>
                      <c:ptCount val="29"/>
                      <c:pt idx="0">
                        <c:v>1.3507670955259161</c:v>
                      </c:pt>
                      <c:pt idx="1">
                        <c:v>3.2291159780506975</c:v>
                      </c:pt>
                      <c:pt idx="2">
                        <c:v>3.67675943736963</c:v>
                      </c:pt>
                      <c:pt idx="3">
                        <c:v>2.1907524609927882</c:v>
                      </c:pt>
                      <c:pt idx="4">
                        <c:v>10.581169526456726</c:v>
                      </c:pt>
                      <c:pt idx="5">
                        <c:v>0.56011521573137391</c:v>
                      </c:pt>
                      <c:pt idx="6">
                        <c:v>1.118232855151212</c:v>
                      </c:pt>
                      <c:pt idx="7">
                        <c:v>1.5152086138961884</c:v>
                      </c:pt>
                      <c:pt idx="8">
                        <c:v>5.5853569758461523</c:v>
                      </c:pt>
                      <c:pt idx="9">
                        <c:v>2.6027189389214276</c:v>
                      </c:pt>
                      <c:pt idx="10">
                        <c:v>1.446663245282642</c:v>
                      </c:pt>
                      <c:pt idx="11">
                        <c:v>1.7027516543453138</c:v>
                      </c:pt>
                      <c:pt idx="12">
                        <c:v>0.61275427033054441</c:v>
                      </c:pt>
                      <c:pt idx="13">
                        <c:v>0.4469226586151761</c:v>
                      </c:pt>
                      <c:pt idx="14">
                        <c:v>0.25610058369560673</c:v>
                      </c:pt>
                      <c:pt idx="15">
                        <c:v>0.49002210788472933</c:v>
                      </c:pt>
                      <c:pt idx="16">
                        <c:v>17.602049334110013</c:v>
                      </c:pt>
                      <c:pt idx="17">
                        <c:v>31.053530300164013</c:v>
                      </c:pt>
                      <c:pt idx="18">
                        <c:v>0.2617212059005139</c:v>
                      </c:pt>
                      <c:pt idx="19">
                        <c:v>6.4450945906545015E-2</c:v>
                      </c:pt>
                      <c:pt idx="20">
                        <c:v>1.0640357597064602</c:v>
                      </c:pt>
                      <c:pt idx="21">
                        <c:v>1.0565399318595159</c:v>
                      </c:pt>
                      <c:pt idx="22">
                        <c:v>0.83749362392621296</c:v>
                      </c:pt>
                      <c:pt idx="23">
                        <c:v>41.006041739636423</c:v>
                      </c:pt>
                      <c:pt idx="24">
                        <c:v>1.0981206737129696</c:v>
                      </c:pt>
                      <c:pt idx="25">
                        <c:v>0.84511275895288163</c:v>
                      </c:pt>
                      <c:pt idx="26">
                        <c:v>0.89127209930005225</c:v>
                      </c:pt>
                      <c:pt idx="27">
                        <c:v>0.21210583065023153</c:v>
                      </c:pt>
                      <c:pt idx="28">
                        <c:v>0.34341705110411436</c:v>
                      </c:pt>
                    </c:numCache>
                  </c:numRef>
                </c:val>
              </c15:ser>
            </c15:filteredBarSeries>
            <c15:filteredBarSeries>
              <c15:ser>
                <c:idx val="3"/>
                <c:order val="3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様々な有機溶媒!$E$1</c15:sqref>
                        </c15:formulaRef>
                      </c:ext>
                    </c:extLst>
                    <c:strCache>
                      <c:ptCount val="1"/>
                      <c:pt idx="0">
                        <c:v>No304_sorghum_H2SO4_IPA</c:v>
                      </c:pt>
                    </c:strCache>
                  </c:strRef>
                </c:tx>
                <c:spPr>
                  <a:solidFill>
                    <a:schemeClr val="accent4"/>
                  </a:solidFill>
                  <a:ln>
                    <a:noFill/>
                  </a:ln>
                  <a:effectLst/>
                </c:spPr>
                <c:invertIfNegative val="0"/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様々な有機溶媒!$J$2:$J$48</c15:sqref>
                        </c15:formulaRef>
                      </c:ext>
                    </c:extLst>
                    <c:strCache>
                      <c:ptCount val="29"/>
                      <c:pt idx="0">
                        <c:v>p-Coumarate (1)</c:v>
                      </c:pt>
                      <c:pt idx="1">
                        <c:v>p-Coumarate (2)</c:v>
                      </c:pt>
                      <c:pt idx="2">
                        <c:v>p-Coumarate (3)</c:v>
                      </c:pt>
                      <c:pt idx="3">
                        <c:v>p-Coumarate (4)</c:v>
                      </c:pt>
                      <c:pt idx="4">
                        <c:v>p-Coumarate (5)</c:v>
                      </c:pt>
                      <c:pt idx="5">
                        <c:v>p-Coumarate (6)</c:v>
                      </c:pt>
                      <c:pt idx="6">
                        <c:v>Guaiacyl (7)</c:v>
                      </c:pt>
                      <c:pt idx="7">
                        <c:v>Guaiacyl (8)</c:v>
                      </c:pt>
                      <c:pt idx="8">
                        <c:v>Guaiacyl (9)</c:v>
                      </c:pt>
                      <c:pt idx="9">
                        <c:v>Guaiacyl (10)</c:v>
                      </c:pt>
                      <c:pt idx="10">
                        <c:v>Syringyl (11)</c:v>
                      </c:pt>
                      <c:pt idx="11">
                        <c:v>Syringyl (12)</c:v>
                      </c:pt>
                      <c:pt idx="12">
                        <c:v>p-Hydroxyphenyl (13)</c:v>
                      </c:pt>
                      <c:pt idx="13">
                        <c:v>Cinnamyl alcohol (14)</c:v>
                      </c:pt>
                      <c:pt idx="14">
                        <c:v>Ferulate (15)</c:v>
                      </c:pt>
                      <c:pt idx="15">
                        <c:v>Ferulate (16)</c:v>
                      </c:pt>
                      <c:pt idx="16">
                        <c:v>Methoxyl (17)</c:v>
                      </c:pt>
                      <c:pt idx="17">
                        <c:v>Methoxyl (18)</c:v>
                      </c:pt>
                      <c:pt idx="18">
                        <c:v>5-5/4-O-β (19)</c:v>
                      </c:pt>
                      <c:pt idx="19">
                        <c:v>5-5/4-O-β (20)</c:v>
                      </c:pt>
                      <c:pt idx="20">
                        <c:v>β-O-4 (21)</c:v>
                      </c:pt>
                      <c:pt idx="21">
                        <c:v>β-O-4 (22)</c:v>
                      </c:pt>
                      <c:pt idx="22">
                        <c:v>β-O-4 (23)</c:v>
                      </c:pt>
                      <c:pt idx="23">
                        <c:v>β-O-4-H/G (24)</c:v>
                      </c:pt>
                      <c:pt idx="24">
                        <c:v>β-O-4-H/G (25)</c:v>
                      </c:pt>
                      <c:pt idx="25">
                        <c:v>β-O-4-H/G (26)</c:v>
                      </c:pt>
                      <c:pt idx="26">
                        <c:v>β-O-4-H/G (27)</c:v>
                      </c:pt>
                      <c:pt idx="27">
                        <c:v>β-O-4-S (28)</c:v>
                      </c:pt>
                      <c:pt idx="28">
                        <c:v>β-5 (29)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様々な有機溶媒!$E$2:$E$48</c15:sqref>
                        </c15:formulaRef>
                      </c:ext>
                    </c:extLst>
                    <c:numCache>
                      <c:formatCode>General</c:formatCode>
                      <c:ptCount val="29"/>
                      <c:pt idx="0">
                        <c:v>1.1924695490022243</c:v>
                      </c:pt>
                      <c:pt idx="1">
                        <c:v>2.7402870815902491</c:v>
                      </c:pt>
                      <c:pt idx="2">
                        <c:v>3.1078985890713162</c:v>
                      </c:pt>
                      <c:pt idx="3">
                        <c:v>1.8216161749050201</c:v>
                      </c:pt>
                      <c:pt idx="4">
                        <c:v>9.1991319677960188</c:v>
                      </c:pt>
                      <c:pt idx="5">
                        <c:v>0.7363838165861436</c:v>
                      </c:pt>
                      <c:pt idx="6">
                        <c:v>0.90476255928777116</c:v>
                      </c:pt>
                      <c:pt idx="7">
                        <c:v>1.4083635969730797</c:v>
                      </c:pt>
                      <c:pt idx="8">
                        <c:v>4.8032001078658624</c:v>
                      </c:pt>
                      <c:pt idx="9">
                        <c:v>2.6976574846505503</c:v>
                      </c:pt>
                      <c:pt idx="10">
                        <c:v>1.2498112511032851</c:v>
                      </c:pt>
                      <c:pt idx="11">
                        <c:v>1.5326727858289915</c:v>
                      </c:pt>
                      <c:pt idx="12">
                        <c:v>0.48307445199003679</c:v>
                      </c:pt>
                      <c:pt idx="13">
                        <c:v>0.43805321753461707</c:v>
                      </c:pt>
                      <c:pt idx="14">
                        <c:v>0.19172469856629382</c:v>
                      </c:pt>
                      <c:pt idx="15">
                        <c:v>0.43972062217919805</c:v>
                      </c:pt>
                      <c:pt idx="16">
                        <c:v>16.416961776016667</c:v>
                      </c:pt>
                      <c:pt idx="17">
                        <c:v>27.229009110018271</c:v>
                      </c:pt>
                      <c:pt idx="18">
                        <c:v>0.20209827902241326</c:v>
                      </c:pt>
                      <c:pt idx="19">
                        <c:v>0.17030730316689069</c:v>
                      </c:pt>
                      <c:pt idx="20">
                        <c:v>0.78079405114530576</c:v>
                      </c:pt>
                      <c:pt idx="21">
                        <c:v>0.79828167324301536</c:v>
                      </c:pt>
                      <c:pt idx="22">
                        <c:v>0.7436055277327519</c:v>
                      </c:pt>
                      <c:pt idx="23">
                        <c:v>41.167438516294588</c:v>
                      </c:pt>
                      <c:pt idx="24">
                        <c:v>1.0030441998044932</c:v>
                      </c:pt>
                      <c:pt idx="25">
                        <c:v>0.72525065886210027</c:v>
                      </c:pt>
                      <c:pt idx="26">
                        <c:v>0.75007126150370118</c:v>
                      </c:pt>
                      <c:pt idx="27">
                        <c:v>0.20095482233386253</c:v>
                      </c:pt>
                      <c:pt idx="28">
                        <c:v>0.26878562870645728</c:v>
                      </c:pt>
                    </c:numCache>
                  </c:numRef>
                </c:val>
              </c15:ser>
            </c15:filteredBarSeries>
            <c15:filteredBarSeries>
              <c15:ser>
                <c:idx val="4"/>
                <c:order val="4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様々な有機溶媒!$F$1</c15:sqref>
                        </c15:formulaRef>
                      </c:ext>
                    </c:extLst>
                    <c:strCache>
                      <c:ptCount val="1"/>
                      <c:pt idx="0">
                        <c:v>No313_sorghum_H2SO4_PrOH_sol</c:v>
                      </c:pt>
                    </c:strCache>
                  </c:strRef>
                </c:tx>
                <c:spPr>
                  <a:solidFill>
                    <a:schemeClr val="accent5"/>
                  </a:solidFill>
                  <a:ln>
                    <a:noFill/>
                  </a:ln>
                  <a:effectLst/>
                </c:spPr>
                <c:invertIfNegative val="0"/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様々な有機溶媒!$J$2:$J$48</c15:sqref>
                        </c15:formulaRef>
                      </c:ext>
                    </c:extLst>
                    <c:strCache>
                      <c:ptCount val="29"/>
                      <c:pt idx="0">
                        <c:v>p-Coumarate (1)</c:v>
                      </c:pt>
                      <c:pt idx="1">
                        <c:v>p-Coumarate (2)</c:v>
                      </c:pt>
                      <c:pt idx="2">
                        <c:v>p-Coumarate (3)</c:v>
                      </c:pt>
                      <c:pt idx="3">
                        <c:v>p-Coumarate (4)</c:v>
                      </c:pt>
                      <c:pt idx="4">
                        <c:v>p-Coumarate (5)</c:v>
                      </c:pt>
                      <c:pt idx="5">
                        <c:v>p-Coumarate (6)</c:v>
                      </c:pt>
                      <c:pt idx="6">
                        <c:v>Guaiacyl (7)</c:v>
                      </c:pt>
                      <c:pt idx="7">
                        <c:v>Guaiacyl (8)</c:v>
                      </c:pt>
                      <c:pt idx="8">
                        <c:v>Guaiacyl (9)</c:v>
                      </c:pt>
                      <c:pt idx="9">
                        <c:v>Guaiacyl (10)</c:v>
                      </c:pt>
                      <c:pt idx="10">
                        <c:v>Syringyl (11)</c:v>
                      </c:pt>
                      <c:pt idx="11">
                        <c:v>Syringyl (12)</c:v>
                      </c:pt>
                      <c:pt idx="12">
                        <c:v>p-Hydroxyphenyl (13)</c:v>
                      </c:pt>
                      <c:pt idx="13">
                        <c:v>Cinnamyl alcohol (14)</c:v>
                      </c:pt>
                      <c:pt idx="14">
                        <c:v>Ferulate (15)</c:v>
                      </c:pt>
                      <c:pt idx="15">
                        <c:v>Ferulate (16)</c:v>
                      </c:pt>
                      <c:pt idx="16">
                        <c:v>Methoxyl (17)</c:v>
                      </c:pt>
                      <c:pt idx="17">
                        <c:v>Methoxyl (18)</c:v>
                      </c:pt>
                      <c:pt idx="18">
                        <c:v>5-5/4-O-β (19)</c:v>
                      </c:pt>
                      <c:pt idx="19">
                        <c:v>5-5/4-O-β (20)</c:v>
                      </c:pt>
                      <c:pt idx="20">
                        <c:v>β-O-4 (21)</c:v>
                      </c:pt>
                      <c:pt idx="21">
                        <c:v>β-O-4 (22)</c:v>
                      </c:pt>
                      <c:pt idx="22">
                        <c:v>β-O-4 (23)</c:v>
                      </c:pt>
                      <c:pt idx="23">
                        <c:v>β-O-4-H/G (24)</c:v>
                      </c:pt>
                      <c:pt idx="24">
                        <c:v>β-O-4-H/G (25)</c:v>
                      </c:pt>
                      <c:pt idx="25">
                        <c:v>β-O-4-H/G (26)</c:v>
                      </c:pt>
                      <c:pt idx="26">
                        <c:v>β-O-4-H/G (27)</c:v>
                      </c:pt>
                      <c:pt idx="27">
                        <c:v>β-O-4-S (28)</c:v>
                      </c:pt>
                      <c:pt idx="28">
                        <c:v>β-5 (29)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様々な有機溶媒!$F$2:$F$48</c15:sqref>
                        </c15:formulaRef>
                      </c:ext>
                    </c:extLst>
                    <c:numCache>
                      <c:formatCode>General</c:formatCode>
                      <c:ptCount val="29"/>
                      <c:pt idx="0">
                        <c:v>2.3219925357114612</c:v>
                      </c:pt>
                      <c:pt idx="1">
                        <c:v>4.9306268786480141</c:v>
                      </c:pt>
                      <c:pt idx="2">
                        <c:v>5.1785333646811216</c:v>
                      </c:pt>
                      <c:pt idx="3">
                        <c:v>2.6144394224618379</c:v>
                      </c:pt>
                      <c:pt idx="4">
                        <c:v>16.142616654391173</c:v>
                      </c:pt>
                      <c:pt idx="5">
                        <c:v>0.94847951570895406</c:v>
                      </c:pt>
                      <c:pt idx="6">
                        <c:v>1.7930088335125789</c:v>
                      </c:pt>
                      <c:pt idx="7">
                        <c:v>2.7152966266516096</c:v>
                      </c:pt>
                      <c:pt idx="8">
                        <c:v>8.614890271084839</c:v>
                      </c:pt>
                      <c:pt idx="9">
                        <c:v>4.1186221463514885</c:v>
                      </c:pt>
                      <c:pt idx="10">
                        <c:v>2.096642468971877</c:v>
                      </c:pt>
                      <c:pt idx="11">
                        <c:v>2.4005424171619456</c:v>
                      </c:pt>
                      <c:pt idx="12">
                        <c:v>0.94948558602519906</c:v>
                      </c:pt>
                      <c:pt idx="13">
                        <c:v>0.59041693813528362</c:v>
                      </c:pt>
                      <c:pt idx="14">
                        <c:v>0.36190931701813672</c:v>
                      </c:pt>
                      <c:pt idx="15">
                        <c:v>0.72705043317514173</c:v>
                      </c:pt>
                      <c:pt idx="16">
                        <c:v>26.983294390700681</c:v>
                      </c:pt>
                      <c:pt idx="17">
                        <c:v>43.719318217889004</c:v>
                      </c:pt>
                      <c:pt idx="18">
                        <c:v>0.38625352864368273</c:v>
                      </c:pt>
                      <c:pt idx="19">
                        <c:v>0.11150487137095104</c:v>
                      </c:pt>
                      <c:pt idx="20">
                        <c:v>1.2364609566706497</c:v>
                      </c:pt>
                      <c:pt idx="21">
                        <c:v>1.2774521349941923</c:v>
                      </c:pt>
                      <c:pt idx="22">
                        <c:v>1.0234688766498612</c:v>
                      </c:pt>
                      <c:pt idx="23">
                        <c:v>63.454363413042437</c:v>
                      </c:pt>
                      <c:pt idx="24">
                        <c:v>1.3853104049728926</c:v>
                      </c:pt>
                      <c:pt idx="25">
                        <c:v>1.0574681352782591</c:v>
                      </c:pt>
                      <c:pt idx="26">
                        <c:v>1.1681993547161833</c:v>
                      </c:pt>
                      <c:pt idx="27">
                        <c:v>0.31464929841390593</c:v>
                      </c:pt>
                      <c:pt idx="28">
                        <c:v>0.49674210759357129</c:v>
                      </c:pt>
                    </c:numCache>
                  </c:numRef>
                </c:val>
              </c15:ser>
            </c15:filteredBarSeries>
          </c:ext>
        </c:extLst>
      </c:barChart>
      <c:catAx>
        <c:axId val="-3005915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-300590960"/>
        <c:crosses val="autoZero"/>
        <c:auto val="1"/>
        <c:lblAlgn val="ctr"/>
        <c:lblOffset val="100"/>
        <c:noMultiLvlLbl val="0"/>
      </c:catAx>
      <c:valAx>
        <c:axId val="-30059096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Peak</a:t>
                </a:r>
                <a:r>
                  <a:rPr lang="ja-JP"/>
                  <a:t> </a:t>
                </a:r>
                <a:r>
                  <a:rPr lang="en-US"/>
                  <a:t>intensity</a:t>
                </a:r>
                <a:endParaRPr lang="ja-JP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-300591504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9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B54F9E-B317-470E-A6C0-1CD4130156B7}" type="datetimeFigureOut">
              <a:rPr kumimoji="1" lang="ja-JP" altLang="en-US" smtClean="0"/>
              <a:t>2015/12/1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78A972A-3CEA-4486-8F38-43F2A1C8A68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35727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49402-42BA-4685-83A9-33769F43DC51}" type="datetimeFigureOut">
              <a:rPr kumimoji="1" lang="ja-JP" altLang="en-US" smtClean="0"/>
              <a:t>2015/12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DBC20-EECC-43A0-A09C-2FC0ED7213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11947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49402-42BA-4685-83A9-33769F43DC51}" type="datetimeFigureOut">
              <a:rPr kumimoji="1" lang="ja-JP" altLang="en-US" smtClean="0"/>
              <a:t>2015/12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DBC20-EECC-43A0-A09C-2FC0ED7213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04434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49402-42BA-4685-83A9-33769F43DC51}" type="datetimeFigureOut">
              <a:rPr kumimoji="1" lang="ja-JP" altLang="en-US" smtClean="0"/>
              <a:t>2015/12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DBC20-EECC-43A0-A09C-2FC0ED7213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09488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49402-42BA-4685-83A9-33769F43DC51}" type="datetimeFigureOut">
              <a:rPr kumimoji="1" lang="ja-JP" altLang="en-US" smtClean="0"/>
              <a:t>2015/12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DBC20-EECC-43A0-A09C-2FC0ED7213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02316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5333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1pPr>
            <a:lvl2pPr marL="609585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49402-42BA-4685-83A9-33769F43DC51}" type="datetimeFigureOut">
              <a:rPr kumimoji="1" lang="ja-JP" altLang="en-US" smtClean="0"/>
              <a:t>2015/12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DBC20-EECC-43A0-A09C-2FC0ED7213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55415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3733"/>
            </a:lvl1pPr>
            <a:lvl2pPr>
              <a:defRPr sz="3200"/>
            </a:lvl2pPr>
            <a:lvl3pPr>
              <a:defRPr sz="2667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3733"/>
            </a:lvl1pPr>
            <a:lvl2pPr>
              <a:defRPr sz="3200"/>
            </a:lvl2pPr>
            <a:lvl3pPr>
              <a:defRPr sz="2667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49402-42BA-4685-83A9-33769F43DC51}" type="datetimeFigureOut">
              <a:rPr kumimoji="1" lang="ja-JP" altLang="en-US" smtClean="0"/>
              <a:t>2015/12/1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DBC20-EECC-43A0-A09C-2FC0ED7213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46518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3200"/>
            </a:lvl1pPr>
            <a:lvl2pPr>
              <a:defRPr sz="2667"/>
            </a:lvl2pPr>
            <a:lvl3pPr>
              <a:defRPr sz="2400"/>
            </a:lvl3pPr>
            <a:lvl4pPr>
              <a:defRPr sz="2133"/>
            </a:lvl4pPr>
            <a:lvl5pPr>
              <a:defRPr sz="2133"/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3200"/>
            </a:lvl1pPr>
            <a:lvl2pPr>
              <a:defRPr sz="2667"/>
            </a:lvl2pPr>
            <a:lvl3pPr>
              <a:defRPr sz="2400"/>
            </a:lvl3pPr>
            <a:lvl4pPr>
              <a:defRPr sz="2133"/>
            </a:lvl4pPr>
            <a:lvl5pPr>
              <a:defRPr sz="2133"/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49402-42BA-4685-83A9-33769F43DC51}" type="datetimeFigureOut">
              <a:rPr kumimoji="1" lang="ja-JP" altLang="en-US" smtClean="0"/>
              <a:t>2015/12/1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DBC20-EECC-43A0-A09C-2FC0ED7213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97410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49402-42BA-4685-83A9-33769F43DC51}" type="datetimeFigureOut">
              <a:rPr kumimoji="1" lang="ja-JP" altLang="en-US" smtClean="0"/>
              <a:t>2015/12/1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DBC20-EECC-43A0-A09C-2FC0ED7213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49969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49402-42BA-4685-83A9-33769F43DC51}" type="datetimeFigureOut">
              <a:rPr kumimoji="1" lang="ja-JP" altLang="en-US" smtClean="0"/>
              <a:t>2015/12/1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DBC20-EECC-43A0-A09C-2FC0ED7213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06635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667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867"/>
            </a:lvl1pPr>
            <a:lvl2pPr marL="609585" indent="0">
              <a:buNone/>
              <a:defRPr sz="1600"/>
            </a:lvl2pPr>
            <a:lvl3pPr marL="1219170" indent="0">
              <a:buNone/>
              <a:defRPr sz="1333"/>
            </a:lvl3pPr>
            <a:lvl4pPr marL="1828754" indent="0">
              <a:buNone/>
              <a:defRPr sz="1200"/>
            </a:lvl4pPr>
            <a:lvl5pPr marL="2438339" indent="0">
              <a:buNone/>
              <a:defRPr sz="1200"/>
            </a:lvl5pPr>
            <a:lvl6pPr marL="3047924" indent="0">
              <a:buNone/>
              <a:defRPr sz="1200"/>
            </a:lvl6pPr>
            <a:lvl7pPr marL="3657509" indent="0">
              <a:buNone/>
              <a:defRPr sz="1200"/>
            </a:lvl7pPr>
            <a:lvl8pPr marL="4267093" indent="0">
              <a:buNone/>
              <a:defRPr sz="1200"/>
            </a:lvl8pPr>
            <a:lvl9pPr marL="4876678" indent="0">
              <a:buNone/>
              <a:defRPr sz="12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49402-42BA-4685-83A9-33769F43DC51}" type="datetimeFigureOut">
              <a:rPr kumimoji="1" lang="ja-JP" altLang="en-US" smtClean="0"/>
              <a:t>2015/12/1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DBC20-EECC-43A0-A09C-2FC0ED7213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87097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667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867"/>
            </a:lvl1pPr>
            <a:lvl2pPr marL="609585" indent="0">
              <a:buNone/>
              <a:defRPr sz="1600"/>
            </a:lvl2pPr>
            <a:lvl3pPr marL="1219170" indent="0">
              <a:buNone/>
              <a:defRPr sz="1333"/>
            </a:lvl3pPr>
            <a:lvl4pPr marL="1828754" indent="0">
              <a:buNone/>
              <a:defRPr sz="1200"/>
            </a:lvl4pPr>
            <a:lvl5pPr marL="2438339" indent="0">
              <a:buNone/>
              <a:defRPr sz="1200"/>
            </a:lvl5pPr>
            <a:lvl6pPr marL="3047924" indent="0">
              <a:buNone/>
              <a:defRPr sz="1200"/>
            </a:lvl6pPr>
            <a:lvl7pPr marL="3657509" indent="0">
              <a:buNone/>
              <a:defRPr sz="1200"/>
            </a:lvl7pPr>
            <a:lvl8pPr marL="4267093" indent="0">
              <a:buNone/>
              <a:defRPr sz="1200"/>
            </a:lvl8pPr>
            <a:lvl9pPr marL="4876678" indent="0">
              <a:buNone/>
              <a:defRPr sz="12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49402-42BA-4685-83A9-33769F43DC51}" type="datetimeFigureOut">
              <a:rPr kumimoji="1" lang="ja-JP" altLang="en-US" smtClean="0"/>
              <a:t>2015/12/1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DDBC20-EECC-43A0-A09C-2FC0ED7213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9006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549402-42BA-4685-83A9-33769F43DC51}" type="datetimeFigureOut">
              <a:rPr kumimoji="1" lang="ja-JP" altLang="en-US" smtClean="0"/>
              <a:t>2015/12/1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DDBC20-EECC-43A0-A09C-2FC0ED72136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57271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219170" rtl="0" eaLnBrk="1" latinLnBrk="0" hangingPunct="1">
        <a:spcBef>
          <a:spcPct val="0"/>
        </a:spcBef>
        <a:buNone/>
        <a:defRPr kumimoji="1"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7189" indent="-457189" algn="l" defTabSz="121917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4267" kern="1200">
          <a:solidFill>
            <a:schemeClr val="tx1"/>
          </a:solidFill>
          <a:latin typeface="+mn-lt"/>
          <a:ea typeface="+mn-ea"/>
          <a:cs typeface="+mn-cs"/>
        </a:defRPr>
      </a:lvl1pPr>
      <a:lvl2pPr marL="990575" indent="-380990" algn="l" defTabSz="121917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3733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グラフ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03634148"/>
              </p:ext>
            </p:extLst>
          </p:nvPr>
        </p:nvGraphicFramePr>
        <p:xfrm>
          <a:off x="158418" y="227268"/>
          <a:ext cx="6120000" cy="34892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正方形/長方形 5"/>
          <p:cNvSpPr/>
          <p:nvPr/>
        </p:nvSpPr>
        <p:spPr>
          <a:xfrm>
            <a:off x="5273491" y="545875"/>
            <a:ext cx="72000" cy="66462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ja-JP" sz="9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正方形/長方形 6"/>
          <p:cNvSpPr/>
          <p:nvPr/>
        </p:nvSpPr>
        <p:spPr>
          <a:xfrm>
            <a:off x="5273491" y="675878"/>
            <a:ext cx="72000" cy="66462"/>
          </a:xfrm>
          <a:prstGeom prst="rect">
            <a:avLst/>
          </a:prstGeom>
          <a:solidFill>
            <a:schemeClr val="accent6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ja-JP" sz="9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正方形/長方形 7"/>
          <p:cNvSpPr/>
          <p:nvPr/>
        </p:nvSpPr>
        <p:spPr>
          <a:xfrm>
            <a:off x="5273491" y="805879"/>
            <a:ext cx="72000" cy="66462"/>
          </a:xfrm>
          <a:prstGeom prst="rect">
            <a:avLst/>
          </a:prstGeom>
          <a:solidFill>
            <a:srgbClr val="255E9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/>
          <a:lstStyle>
            <a:lvl1pPr marL="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endParaRPr lang="ja-JP" sz="9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5309491" y="711265"/>
            <a:ext cx="7344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-pentano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5309491" y="567195"/>
            <a:ext cx="6767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-butano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5309492" y="451260"/>
            <a:ext cx="5757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tro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1740151" y="3820661"/>
            <a:ext cx="353334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_file_3 </a:t>
            </a:r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 </a:t>
            </a:r>
            <a:r>
              <a:rPr lang="en-US" altLang="ja-JP" sz="2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PTX</a:t>
            </a:r>
            <a:endParaRPr lang="en-US" altLang="ja-JP" sz="2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571319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49</TotalTime>
  <Words>8</Words>
  <Application>Microsoft Office PowerPoint</Application>
  <PresentationFormat>画面に合わせる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Times New Roman</vt:lpstr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PCUser</dc:creator>
  <cp:lastModifiedBy>寺村浩</cp:lastModifiedBy>
  <cp:revision>36</cp:revision>
  <dcterms:created xsi:type="dcterms:W3CDTF">2015-11-18T01:14:49Z</dcterms:created>
  <dcterms:modified xsi:type="dcterms:W3CDTF">2015-12-16T07:53:33Z</dcterms:modified>
</cp:coreProperties>
</file>